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D3CF3-F3FC-4522-8947-4B67DF970A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4E3C0-9B73-4121-B054-E9B9F4C11F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95671-F755-48B7-A6B3-673759D687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9CE96-5175-49F7-BE30-17E3A1DB1F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5D935-D6E4-44CC-A7EE-D3AD62E759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C1B52-4675-40DC-8D45-F3A7404D16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CED21-4253-4B55-A3B8-1049513B88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B08B4-19F1-4E55-82E7-E8D243BEAB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96B72-D9F7-4059-AB87-0B16A82665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9FB3C-1A87-49E5-BA60-C3D857850D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CDC60-6874-48CD-B2AB-8B73AFB9A3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355FB-FD41-499E-B193-6A3369C858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9496DC-68E6-428E-84A8-AF0EC537664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1082520" y="3673440"/>
            <a:ext cx="44960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-1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reatment three times per week of 12424 did not inhibit tumor growth. 12424 tumors implanted SQ into mice and given 200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 of Drozitumab 3x/wk. n=8 mice/group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1"/>
          <p:cNvGraphicFramePr/>
          <p:nvPr/>
        </p:nvGraphicFramePr>
        <p:xfrm>
          <a:off x="1969920" y="1774800"/>
          <a:ext cx="2479680" cy="1711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69920" y="1774800"/>
                    <a:ext cx="2479680" cy="171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TextBox 4"/>
          <p:cNvSpPr/>
          <p:nvPr/>
        </p:nvSpPr>
        <p:spPr>
          <a:xfrm>
            <a:off x="581760" y="8240760"/>
            <a:ext cx="539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ng, Mace  Supplemental Figure 1, black and wh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"/>
          <p:cNvSpPr/>
          <p:nvPr/>
        </p:nvSpPr>
        <p:spPr>
          <a:xfrm>
            <a:off x="2940480" y="330120"/>
            <a:ext cx="355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ng, Mace Supplemental Figur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12"/>
          <p:cNvSpPr/>
          <p:nvPr/>
        </p:nvSpPr>
        <p:spPr>
          <a:xfrm>
            <a:off x="1824120" y="2076480"/>
            <a:ext cx="33811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-2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umors derived from purified CSCs recapitulate the morphology of the original patient xenograft. H&amp;E images of the patient pancreatic adenocarcinoma xenograft 14244 (A) and the tumor derived from CSCs isolated from that tumor (B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6" descr=""/>
          <p:cNvPicPr/>
          <p:nvPr/>
        </p:nvPicPr>
        <p:blipFill>
          <a:blip r:embed="rId1"/>
          <a:stretch/>
        </p:blipFill>
        <p:spPr>
          <a:xfrm>
            <a:off x="2124000" y="885960"/>
            <a:ext cx="1405080" cy="993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8" name="Picture 7" descr=""/>
          <p:cNvPicPr/>
          <p:nvPr/>
        </p:nvPicPr>
        <p:blipFill>
          <a:blip r:embed="rId2"/>
          <a:stretch/>
        </p:blipFill>
        <p:spPr>
          <a:xfrm>
            <a:off x="3673440" y="885960"/>
            <a:ext cx="1359000" cy="993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TextBox 3"/>
          <p:cNvSpPr/>
          <p:nvPr/>
        </p:nvSpPr>
        <p:spPr>
          <a:xfrm>
            <a:off x="3535920" y="485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"/>
          <p:cNvSpPr/>
          <p:nvPr/>
        </p:nvSpPr>
        <p:spPr>
          <a:xfrm>
            <a:off x="1997640" y="485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"/>
          <p:cNvSpPr/>
          <p:nvPr/>
        </p:nvSpPr>
        <p:spPr>
          <a:xfrm>
            <a:off x="576000" y="8240760"/>
            <a:ext cx="431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ng, Mace  Supplemental Figure 2, col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10"/>
          <p:cNvGrpSpPr/>
          <p:nvPr/>
        </p:nvGrpSpPr>
        <p:grpSpPr>
          <a:xfrm>
            <a:off x="1673280" y="2641680"/>
            <a:ext cx="1674720" cy="1530360"/>
            <a:chOff x="1673280" y="2641680"/>
            <a:chExt cx="1674720" cy="1530360"/>
          </a:xfrm>
        </p:grpSpPr>
        <p:pic>
          <p:nvPicPr>
            <p:cNvPr id="53" name="Picture 72" descr=""/>
            <p:cNvPicPr/>
            <p:nvPr/>
          </p:nvPicPr>
          <p:blipFill>
            <a:blip r:embed="rId1">
              <a:grayscl/>
            </a:blip>
            <a:srcRect l="17785" t="10514" r="0" b="14267"/>
            <a:stretch/>
          </p:blipFill>
          <p:spPr>
            <a:xfrm>
              <a:off x="1673280" y="2641680"/>
              <a:ext cx="1674720" cy="153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Rectangle 9"/>
            <p:cNvSpPr/>
            <p:nvPr/>
          </p:nvSpPr>
          <p:spPr>
            <a:xfrm>
              <a:off x="1711080" y="2655720"/>
              <a:ext cx="1571760" cy="14670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0"/>
            <p:cNvSpPr/>
            <p:nvPr/>
          </p:nvSpPr>
          <p:spPr>
            <a:xfrm>
              <a:off x="2688840" y="2665440"/>
              <a:ext cx="57852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.54%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Group 8"/>
          <p:cNvGrpSpPr/>
          <p:nvPr/>
        </p:nvGrpSpPr>
        <p:grpSpPr>
          <a:xfrm>
            <a:off x="3376440" y="2641680"/>
            <a:ext cx="1675080" cy="1530360"/>
            <a:chOff x="3376440" y="2641680"/>
            <a:chExt cx="1675080" cy="1530360"/>
          </a:xfrm>
        </p:grpSpPr>
        <p:pic>
          <p:nvPicPr>
            <p:cNvPr id="57" name="Picture 19" descr=""/>
            <p:cNvPicPr/>
            <p:nvPr/>
          </p:nvPicPr>
          <p:blipFill>
            <a:blip r:embed="rId2">
              <a:grayscl/>
            </a:blip>
            <a:srcRect l="17852" t="10607" r="0" b="14256"/>
            <a:stretch/>
          </p:blipFill>
          <p:spPr>
            <a:xfrm>
              <a:off x="3376440" y="2641680"/>
              <a:ext cx="1675080" cy="153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Rectangle 11"/>
            <p:cNvSpPr/>
            <p:nvPr/>
          </p:nvSpPr>
          <p:spPr>
            <a:xfrm>
              <a:off x="3412800" y="2654280"/>
              <a:ext cx="1572120" cy="14670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3"/>
            <p:cNvSpPr/>
            <p:nvPr/>
          </p:nvSpPr>
          <p:spPr>
            <a:xfrm>
              <a:off x="4389120" y="2668320"/>
              <a:ext cx="57852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.89%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60" name="Straight Arrow Connector 14"/>
          <p:cNvCxnSpPr/>
          <p:nvPr/>
        </p:nvCxnSpPr>
        <p:spPr>
          <a:xfrm flipV="1">
            <a:off x="1615680" y="1086840"/>
            <a:ext cx="1080" cy="3120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1" name="Straight Arrow Connector 16"/>
          <p:cNvCxnSpPr/>
          <p:nvPr/>
        </p:nvCxnSpPr>
        <p:spPr>
          <a:xfrm>
            <a:off x="1616040" y="4206600"/>
            <a:ext cx="33696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2" name="TextBox 20"/>
          <p:cNvSpPr/>
          <p:nvPr/>
        </p:nvSpPr>
        <p:spPr>
          <a:xfrm rot="16200000">
            <a:off x="1186200" y="368028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4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2"/>
          <p:cNvSpPr/>
          <p:nvPr/>
        </p:nvSpPr>
        <p:spPr>
          <a:xfrm>
            <a:off x="1653480" y="421020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1"/>
          <p:cNvSpPr/>
          <p:nvPr/>
        </p:nvSpPr>
        <p:spPr>
          <a:xfrm>
            <a:off x="1712520" y="704880"/>
            <a:ext cx="85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4"/>
          <p:cNvSpPr/>
          <p:nvPr/>
        </p:nvSpPr>
        <p:spPr>
          <a:xfrm>
            <a:off x="3418200" y="704880"/>
            <a:ext cx="152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st-Drozitumab T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3"/>
          <p:cNvSpPr/>
          <p:nvPr/>
        </p:nvSpPr>
        <p:spPr>
          <a:xfrm>
            <a:off x="450720" y="3160800"/>
            <a:ext cx="81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4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6"/>
          <p:cNvSpPr/>
          <p:nvPr/>
        </p:nvSpPr>
        <p:spPr>
          <a:xfrm>
            <a:off x="405720" y="1631880"/>
            <a:ext cx="90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nc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6"/>
          <p:cNvGrpSpPr/>
          <p:nvPr/>
        </p:nvGrpSpPr>
        <p:grpSpPr>
          <a:xfrm>
            <a:off x="1673280" y="1058760"/>
            <a:ext cx="1662120" cy="1533600"/>
            <a:chOff x="1673280" y="1058760"/>
            <a:chExt cx="1662120" cy="1533600"/>
          </a:xfrm>
        </p:grpSpPr>
        <p:grpSp>
          <p:nvGrpSpPr>
            <p:cNvPr id="69" name="Group 2"/>
            <p:cNvGrpSpPr/>
            <p:nvPr/>
          </p:nvGrpSpPr>
          <p:grpSpPr>
            <a:xfrm>
              <a:off x="1673280" y="1058760"/>
              <a:ext cx="1662120" cy="1533600"/>
              <a:chOff x="1673280" y="1058760"/>
              <a:chExt cx="1662120" cy="1533600"/>
            </a:xfrm>
          </p:grpSpPr>
          <p:pic>
            <p:nvPicPr>
              <p:cNvPr id="70" name="Picture 17" descr=""/>
              <p:cNvPicPr/>
              <p:nvPr/>
            </p:nvPicPr>
            <p:blipFill>
              <a:blip r:embed="rId3">
                <a:grayscl/>
              </a:blip>
              <a:srcRect l="17735" t="10398" r="1190" b="13523"/>
              <a:stretch/>
            </p:blipFill>
            <p:spPr>
              <a:xfrm>
                <a:off x="1673280" y="1058760"/>
                <a:ext cx="1662120" cy="1533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1" name="Rectangle 1"/>
              <p:cNvSpPr/>
              <p:nvPr/>
            </p:nvSpPr>
            <p:spPr>
              <a:xfrm>
                <a:off x="1708200" y="1076040"/>
                <a:ext cx="1579680" cy="1447920"/>
              </a:xfrm>
              <a:prstGeom prst="rect">
                <a:avLst/>
              </a:prstGeom>
              <a:noFill/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TextBox 4"/>
            <p:cNvSpPr/>
            <p:nvPr/>
          </p:nvSpPr>
          <p:spPr>
            <a:xfrm>
              <a:off x="2692800" y="1086840"/>
              <a:ext cx="57852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.99%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Group 5"/>
          <p:cNvGrpSpPr/>
          <p:nvPr/>
        </p:nvGrpSpPr>
        <p:grpSpPr>
          <a:xfrm>
            <a:off x="3368520" y="1044720"/>
            <a:ext cx="1675080" cy="1542960"/>
            <a:chOff x="3368520" y="1044720"/>
            <a:chExt cx="1675080" cy="1542960"/>
          </a:xfrm>
        </p:grpSpPr>
        <p:grpSp>
          <p:nvGrpSpPr>
            <p:cNvPr id="74" name="Group 3"/>
            <p:cNvGrpSpPr/>
            <p:nvPr/>
          </p:nvGrpSpPr>
          <p:grpSpPr>
            <a:xfrm>
              <a:off x="3368520" y="1044720"/>
              <a:ext cx="1675080" cy="1542960"/>
              <a:chOff x="3368520" y="1044720"/>
              <a:chExt cx="1675080" cy="1542960"/>
            </a:xfrm>
          </p:grpSpPr>
          <p:pic>
            <p:nvPicPr>
              <p:cNvPr id="75" name="Picture 18" descr=""/>
              <p:cNvPicPr/>
              <p:nvPr/>
            </p:nvPicPr>
            <p:blipFill>
              <a:blip r:embed="rId4">
                <a:grayscl/>
              </a:blip>
              <a:srcRect l="17552" t="10319" r="0" b="13667"/>
              <a:stretch/>
            </p:blipFill>
            <p:spPr>
              <a:xfrm>
                <a:off x="3368520" y="1044720"/>
                <a:ext cx="1675080" cy="1542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6" name="Rectangle 19"/>
              <p:cNvSpPr/>
              <p:nvPr/>
            </p:nvSpPr>
            <p:spPr>
              <a:xfrm>
                <a:off x="3408120" y="1062000"/>
                <a:ext cx="1564200" cy="1459080"/>
              </a:xfrm>
              <a:prstGeom prst="rect">
                <a:avLst/>
              </a:prstGeom>
              <a:noFill/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TextBox 23"/>
            <p:cNvSpPr/>
            <p:nvPr/>
          </p:nvSpPr>
          <p:spPr>
            <a:xfrm>
              <a:off x="4382640" y="1073520"/>
              <a:ext cx="57852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.22%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Text Box 22"/>
          <p:cNvSpPr/>
          <p:nvPr/>
        </p:nvSpPr>
        <p:spPr>
          <a:xfrm>
            <a:off x="326880" y="4916520"/>
            <a:ext cx="61722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-3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n vitro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eatment of tumor cells with drozitumab depletes cancer stem cells. A) Panc-1 pancreatic tumor cells or dissociated tumor cells from B) 12424 were treat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n vitro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ith 10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/ml of drozitumab and 10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/ml of anti-human IgG Fc antibody for 12hrs to ensure maximum killing. The percentages of CSCs were assessed by flow cytometry using markers for ESA, CD44, and CD24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"/>
          <p:cNvSpPr/>
          <p:nvPr/>
        </p:nvSpPr>
        <p:spPr>
          <a:xfrm>
            <a:off x="230760" y="126036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30"/>
          <p:cNvSpPr/>
          <p:nvPr/>
        </p:nvSpPr>
        <p:spPr>
          <a:xfrm>
            <a:off x="230760" y="288756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4"/>
          <p:cNvSpPr/>
          <p:nvPr/>
        </p:nvSpPr>
        <p:spPr>
          <a:xfrm>
            <a:off x="581760" y="8240760"/>
            <a:ext cx="539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ng, Mace  Supplemental Figure 3, black and wh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6T20:10:20Z</dcterms:created>
  <dc:creator>mace</dc:creator>
  <dc:description/>
  <dc:language>en-US</dc:language>
  <cp:lastModifiedBy>Hylander, Bonnie</cp:lastModifiedBy>
  <cp:lastPrinted>2015-06-01T20:05:26Z</cp:lastPrinted>
  <dcterms:modified xsi:type="dcterms:W3CDTF">2015-10-26T21:20:15Z</dcterms:modified>
  <cp:revision>392</cp:revision>
  <dc:subject/>
  <dc:title>Slide 1</dc:title>
</cp:coreProperties>
</file>